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  <p:embeddedFont>
      <p:font typeface="Calibri Light" panose="020F0302020204030204" pitchFamily="34" charset="0"/>
      <p:regular r:id="rId7"/>
      <p:italic r:id="rId8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90" y="-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heme" Target="theme/theme1.xml"/><Relationship Id="rId5" Type="http://schemas.openxmlformats.org/officeDocument/2006/relationships/font" Target="fonts/font3.fntdata"/><Relationship Id="rId10" Type="http://schemas.openxmlformats.org/officeDocument/2006/relationships/viewProps" Target="viewProps.xml"/><Relationship Id="rId4" Type="http://schemas.openxmlformats.org/officeDocument/2006/relationships/font" Target="fonts/font2.fntdata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1432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7489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2488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9337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0933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01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7632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9693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6983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5213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2932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8A3D39-2C21-4A3E-BB43-AF9EF7890EF7}" type="datetimeFigureOut">
              <a:rPr lang="ko-KR" altLang="en-US" smtClean="0"/>
              <a:t>2022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19D03-08CD-4AEA-BCA2-D32A3D3148A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3661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D46B19E8-7923-4ADA-B0BD-D9F834683F2D}"/>
              </a:ext>
            </a:extLst>
          </p:cNvPr>
          <p:cNvGrpSpPr/>
          <p:nvPr/>
        </p:nvGrpSpPr>
        <p:grpSpPr>
          <a:xfrm>
            <a:off x="375292" y="278222"/>
            <a:ext cx="5470706" cy="4838435"/>
            <a:chOff x="268032" y="-1"/>
            <a:chExt cx="8133432" cy="6785640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9F315D70-3028-4E26-A530-89FC428748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30000"/>
                      </a14:imgEffect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r="51978" b="51978"/>
            <a:stretch/>
          </p:blipFill>
          <p:spPr>
            <a:xfrm>
              <a:off x="268032" y="357672"/>
              <a:ext cx="3941112" cy="2969729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CE8BE8E2-6062-435E-BAEB-895D3923E1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30000"/>
                      </a14:imgEffect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60351" y="357673"/>
              <a:ext cx="3941113" cy="2969730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AA305199-386C-4E04-A600-FC5A81CFD4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30000"/>
                      </a14:imgEffect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8032" y="3815910"/>
              <a:ext cx="3941112" cy="2969729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97EF94FE-619E-4B17-A3F2-A4EB92EF05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30000"/>
                      </a14:imgEffect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60351" y="3815909"/>
              <a:ext cx="3941113" cy="2969730"/>
            </a:xfrm>
            <a:prstGeom prst="rect">
              <a:avLst/>
            </a:prstGeom>
          </p:spPr>
        </p:pic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3E1ADEA4-8EBF-48A3-9568-7FA1BD5DAA9E}"/>
                </a:ext>
              </a:extLst>
            </p:cNvPr>
            <p:cNvCxnSpPr/>
            <p:nvPr/>
          </p:nvCxnSpPr>
          <p:spPr>
            <a:xfrm>
              <a:off x="2535182" y="3185568"/>
              <a:ext cx="156995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DBC9CF4-0D88-43F0-9CDB-A5FF2D5D2A77}"/>
                </a:ext>
              </a:extLst>
            </p:cNvPr>
            <p:cNvSpPr txBox="1"/>
            <p:nvPr/>
          </p:nvSpPr>
          <p:spPr>
            <a:xfrm>
              <a:off x="268032" y="0"/>
              <a:ext cx="3941113" cy="431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/>
                <a:t>0</a:t>
              </a:r>
              <a:r>
                <a:rPr lang="en-US" altLang="ko-KR" sz="1400" b="1" dirty="0">
                  <a:latin typeface="Symbol" panose="05050102010706020507" pitchFamily="18" charset="2"/>
                </a:rPr>
                <a:t>m</a:t>
              </a:r>
              <a:r>
                <a:rPr lang="en-US" altLang="ko-KR" sz="1400" b="1" dirty="0"/>
                <a:t>M atRA</a:t>
              </a:r>
              <a:endParaRPr lang="ko-KR" altLang="en-US" sz="1400" b="1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C6552F0-E8BF-410B-A95A-F9CC5E4C3ED0}"/>
                </a:ext>
              </a:extLst>
            </p:cNvPr>
            <p:cNvSpPr txBox="1"/>
            <p:nvPr/>
          </p:nvSpPr>
          <p:spPr>
            <a:xfrm>
              <a:off x="4460351" y="-1"/>
              <a:ext cx="3941113" cy="431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/>
                <a:t>100</a:t>
              </a:r>
              <a:r>
                <a:rPr lang="en-US" altLang="ko-KR" sz="1400" b="1" dirty="0">
                  <a:latin typeface="Symbol" panose="05050102010706020507" pitchFamily="18" charset="2"/>
                </a:rPr>
                <a:t>m</a:t>
              </a:r>
              <a:r>
                <a:rPr lang="en-US" altLang="ko-KR" sz="1400" b="1" dirty="0"/>
                <a:t>M atRA</a:t>
              </a:r>
              <a:endParaRPr lang="ko-KR" altLang="en-US" sz="1400" b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EA11C55-DA5C-4A3E-A383-9D1E9169F859}"/>
                </a:ext>
              </a:extLst>
            </p:cNvPr>
            <p:cNvSpPr txBox="1"/>
            <p:nvPr/>
          </p:nvSpPr>
          <p:spPr>
            <a:xfrm>
              <a:off x="268032" y="3461657"/>
              <a:ext cx="3941113" cy="431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/>
                <a:t>150</a:t>
              </a:r>
              <a:r>
                <a:rPr lang="en-US" altLang="ko-KR" sz="1400" b="1" dirty="0">
                  <a:latin typeface="Symbol" panose="05050102010706020507" pitchFamily="18" charset="2"/>
                </a:rPr>
                <a:t>m</a:t>
              </a:r>
              <a:r>
                <a:rPr lang="en-US" altLang="ko-KR" sz="1400" b="1" dirty="0"/>
                <a:t>M atRA</a:t>
              </a:r>
              <a:endParaRPr lang="ko-KR" altLang="en-US" sz="1400" b="1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359ECB1-CC00-4926-B4FB-E69E8109E106}"/>
                </a:ext>
              </a:extLst>
            </p:cNvPr>
            <p:cNvSpPr txBox="1"/>
            <p:nvPr/>
          </p:nvSpPr>
          <p:spPr>
            <a:xfrm>
              <a:off x="4460351" y="3461656"/>
              <a:ext cx="3941113" cy="431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/>
                <a:t>200</a:t>
              </a:r>
              <a:r>
                <a:rPr lang="en-US" altLang="ko-KR" sz="1400" b="1" dirty="0">
                  <a:latin typeface="Symbol" panose="05050102010706020507" pitchFamily="18" charset="2"/>
                </a:rPr>
                <a:t>m</a:t>
              </a:r>
              <a:r>
                <a:rPr lang="en-US" altLang="ko-KR" sz="1400" b="1" dirty="0"/>
                <a:t>M atRA</a:t>
              </a:r>
              <a:endParaRPr lang="ko-KR" altLang="en-US" sz="1400" b="1" dirty="0"/>
            </a:p>
          </p:txBody>
        </p:sp>
      </p:grpSp>
      <p:pic>
        <p:nvPicPr>
          <p:cNvPr id="15" name="그림 14">
            <a:extLst>
              <a:ext uri="{FF2B5EF4-FFF2-40B4-BE49-F238E27FC236}">
                <a16:creationId xmlns:a16="http://schemas.microsoft.com/office/drawing/2014/main" id="{7A44DC5A-53D2-449E-9992-B70354A42C1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94302" y="533257"/>
            <a:ext cx="2105997" cy="220235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F6026B6E-D2E8-4BA1-9DE8-14A4DEFBC04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515773" y="2914308"/>
            <a:ext cx="1788865" cy="2202349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54E40F62-6AD3-4F0D-9475-3FD64B7B994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056330" y="533257"/>
            <a:ext cx="581940" cy="547958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39A66F7A-587C-4CF6-94F6-DE84082F5D4C}"/>
              </a:ext>
            </a:extLst>
          </p:cNvPr>
          <p:cNvSpPr txBox="1"/>
          <p:nvPr/>
        </p:nvSpPr>
        <p:spPr>
          <a:xfrm>
            <a:off x="88330" y="5309079"/>
            <a:ext cx="8919713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ko-KR" sz="12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1.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Effects of different concentrations of atRA on the lipid accumulation in QM7 cells. Oil Red O (ORO) staining (</a:t>
            </a:r>
            <a:r>
              <a:rPr lang="en-US" altLang="ko-KR" sz="12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and O.D. values (</a:t>
            </a:r>
            <a:r>
              <a:rPr lang="en-US" altLang="ko-KR" sz="12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. QM7 cells were incubated with different concentrations of atRA, 0 to 200 </a:t>
            </a:r>
            <a:r>
              <a:rPr lang="en-US" altLang="ko-KR" sz="1200" dirty="0">
                <a:effectLst/>
                <a:latin typeface="Symbol" panose="05050102010706020507" pitchFamily="18" charset="2"/>
                <a:ea typeface="맑은 고딕" panose="020B0503020000020004" pitchFamily="50" charset="-127"/>
                <a:cs typeface="Times New Roman" panose="02020603050405020304" pitchFamily="18" charset="0"/>
              </a:rPr>
              <a:t>m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, in 10% CS for 48 h. Lipid droplets in cells were visualized under a microscope after ORO staining and quantified by a relative amount of ORO per cell which is normalized by a group of 0 M of atRA. Scale bar: 100 </a:t>
            </a:r>
            <a:r>
              <a:rPr lang="en-US" altLang="ko-KR" sz="1200" dirty="0">
                <a:effectLst/>
                <a:latin typeface="Symbol" panose="05050102010706020507" pitchFamily="18" charset="2"/>
                <a:ea typeface="맑은 고딕" panose="020B0503020000020004" pitchFamily="50" charset="-127"/>
                <a:cs typeface="Times New Roman" panose="02020603050405020304" pitchFamily="18" charset="0"/>
              </a:rPr>
              <a:t>m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. Cell viability analysis (</a:t>
            </a:r>
            <a:r>
              <a:rPr lang="en-US" altLang="ko-KR" sz="12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. Areas (3 areas per plate per replicate) of 4’,6-Diamidino-2-phenylindole dihydrochloride (DAPI) stained cells were randomly selected and counted by NIH image J software and then calculated average of stained nuclei. All data were shown as mean </a:t>
            </a:r>
            <a:r>
              <a:rPr lang="ko-KR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±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SEM (n &gt; 4). One-way ANOVA followed by Tukey’s multiple comparison test was used for statistical analysis by the GraphPad PRISM program and statements of significance noted by a-c are based on testing at </a:t>
            </a:r>
            <a:r>
              <a:rPr lang="en-US" altLang="ko-KR" sz="1200" i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&lt; 0.05. </a:t>
            </a:r>
            <a:endParaRPr lang="ko-KR" altLang="ko-KR" sz="1200" dirty="0">
              <a:effectLst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E1FA7D0-45C1-47F0-89A8-E844EEC2CC47}"/>
              </a:ext>
            </a:extLst>
          </p:cNvPr>
          <p:cNvSpPr txBox="1"/>
          <p:nvPr/>
        </p:nvSpPr>
        <p:spPr>
          <a:xfrm>
            <a:off x="88330" y="4881"/>
            <a:ext cx="3879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B772CDA-2E61-489F-9F5D-9BB0B6B69FA2}"/>
              </a:ext>
            </a:extLst>
          </p:cNvPr>
          <p:cNvSpPr txBox="1"/>
          <p:nvPr/>
        </p:nvSpPr>
        <p:spPr>
          <a:xfrm>
            <a:off x="6063244" y="4881"/>
            <a:ext cx="3879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A594281-1955-4D25-BE27-D3D6F01436C7}"/>
              </a:ext>
            </a:extLst>
          </p:cNvPr>
          <p:cNvSpPr txBox="1"/>
          <p:nvPr/>
        </p:nvSpPr>
        <p:spPr>
          <a:xfrm>
            <a:off x="6063968" y="2689328"/>
            <a:ext cx="3879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8481594"/>
      </p:ext>
    </p:extLst>
  </p:cSld>
  <p:clrMapOvr>
    <a:masterClrMapping/>
  </p:clrMapOvr>
</p:sld>
</file>

<file path=ppt/theme/theme1.xml><?xml version="1.0" encoding="utf-8"?>
<a:theme xmlns:a="http://schemas.openxmlformats.org/drawingml/2006/main" name="Templete 1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emplete 1" id="{5900A8D3-4EFA-40E0-9466-F895F54D08C4}" vid="{6E753225-BB1D-4DA8-AEC9-DD321FAA290D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emplete 1</Template>
  <TotalTime>294</TotalTime>
  <Words>200</Words>
  <Application>Microsoft Office PowerPoint</Application>
  <PresentationFormat>화면 슬라이드 쇼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Times New Roman</vt:lpstr>
      <vt:lpstr>Calibri Light</vt:lpstr>
      <vt:lpstr>Arial</vt:lpstr>
      <vt:lpstr>Symbol</vt:lpstr>
      <vt:lpstr>Calibri</vt:lpstr>
      <vt:lpstr>Templete 1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, Dong Hwan</dc:creator>
  <cp:lastModifiedBy>Kim, Dong Hwan</cp:lastModifiedBy>
  <cp:revision>14</cp:revision>
  <dcterms:created xsi:type="dcterms:W3CDTF">2020-06-25T23:47:38Z</dcterms:created>
  <dcterms:modified xsi:type="dcterms:W3CDTF">2022-01-11T22:58:05Z</dcterms:modified>
</cp:coreProperties>
</file>